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99" r:id="rId5"/>
  </p:sldIdLst>
  <p:sldSz cx="9601200" cy="12801600" type="A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97" autoAdjust="0"/>
    <p:restoredTop sz="94660"/>
  </p:normalViewPr>
  <p:slideViewPr>
    <p:cSldViewPr snapToGrid="0">
      <p:cViewPr>
        <p:scale>
          <a:sx n="100" d="100"/>
          <a:sy n="100" d="100"/>
        </p:scale>
        <p:origin x="1266" y="-24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西田　健太朗" userId="bc94bac3-4cb4-4747-a4e6-674ef9948a55" providerId="ADAL" clId="{6709D6C8-D299-463F-91F2-BE72652812B4}"/>
    <pc:docChg chg="delSld modSld">
      <pc:chgData name="西田　健太朗" userId="bc94bac3-4cb4-4747-a4e6-674ef9948a55" providerId="ADAL" clId="{6709D6C8-D299-463F-91F2-BE72652812B4}" dt="2026-01-09T05:36:06.252" v="16" actId="6549"/>
      <pc:docMkLst>
        <pc:docMk/>
      </pc:docMkLst>
      <pc:sldChg chg="del">
        <pc:chgData name="西田　健太朗" userId="bc94bac3-4cb4-4747-a4e6-674ef9948a55" providerId="ADAL" clId="{6709D6C8-D299-463F-91F2-BE72652812B4}" dt="2026-01-08T08:40:22.129" v="0" actId="2696"/>
        <pc:sldMkLst>
          <pc:docMk/>
          <pc:sldMk cId="3852982278" sldId="298"/>
        </pc:sldMkLst>
      </pc:sldChg>
      <pc:sldChg chg="modSp mod">
        <pc:chgData name="西田　健太朗" userId="bc94bac3-4cb4-4747-a4e6-674ef9948a55" providerId="ADAL" clId="{6709D6C8-D299-463F-91F2-BE72652812B4}" dt="2026-01-09T05:36:06.252" v="16" actId="6549"/>
        <pc:sldMkLst>
          <pc:docMk/>
          <pc:sldMk cId="116731960" sldId="299"/>
        </pc:sldMkLst>
        <pc:spChg chg="mod">
          <ac:chgData name="西田　健太朗" userId="bc94bac3-4cb4-4747-a4e6-674ef9948a55" providerId="ADAL" clId="{6709D6C8-D299-463F-91F2-BE72652812B4}" dt="2026-01-09T05:34:49.644" v="2" actId="255"/>
          <ac:spMkLst>
            <pc:docMk/>
            <pc:sldMk cId="116731960" sldId="299"/>
            <ac:spMk id="2" creationId="{DC8BBC0B-CAFA-444C-4080-202E1F604A05}"/>
          </ac:spMkLst>
        </pc:spChg>
        <pc:spChg chg="mod">
          <ac:chgData name="西田　健太朗" userId="bc94bac3-4cb4-4747-a4e6-674ef9948a55" providerId="ADAL" clId="{6709D6C8-D299-463F-91F2-BE72652812B4}" dt="2026-01-09T05:33:56.390" v="1" actId="1076"/>
          <ac:spMkLst>
            <pc:docMk/>
            <pc:sldMk cId="116731960" sldId="299"/>
            <ac:spMk id="4" creationId="{B415DB94-D47C-44F3-AAE1-5240A12A64BA}"/>
          </ac:spMkLst>
        </pc:spChg>
        <pc:spChg chg="mod">
          <ac:chgData name="西田　健太朗" userId="bc94bac3-4cb4-4747-a4e6-674ef9948a55" providerId="ADAL" clId="{6709D6C8-D299-463F-91F2-BE72652812B4}" dt="2026-01-09T05:36:06.252" v="16" actId="6549"/>
          <ac:spMkLst>
            <pc:docMk/>
            <pc:sldMk cId="116731960" sldId="299"/>
            <ac:spMk id="5" creationId="{0E52A992-55A1-6B0C-346D-A49ED43BBD66}"/>
          </ac:spMkLst>
        </pc:spChg>
        <pc:spChg chg="mod">
          <ac:chgData name="西田　健太朗" userId="bc94bac3-4cb4-4747-a4e6-674ef9948a55" providerId="ADAL" clId="{6709D6C8-D299-463F-91F2-BE72652812B4}" dt="2026-01-09T05:34:49.644" v="2" actId="255"/>
          <ac:spMkLst>
            <pc:docMk/>
            <pc:sldMk cId="116731960" sldId="299"/>
            <ac:spMk id="21" creationId="{EE1221E5-69E5-A962-7F52-2126564B3877}"/>
          </ac:spMkLst>
        </pc:spChg>
      </pc:sldChg>
      <pc:sldChg chg="del">
        <pc:chgData name="西田　健太朗" userId="bc94bac3-4cb4-4747-a4e6-674ef9948a55" providerId="ADAL" clId="{6709D6C8-D299-463F-91F2-BE72652812B4}" dt="2026-01-08T08:40:22.129" v="0" actId="2696"/>
        <pc:sldMkLst>
          <pc:docMk/>
          <pc:sldMk cId="3918428493" sldId="300"/>
        </pc:sldMkLst>
      </pc:sldChg>
      <pc:sldChg chg="del">
        <pc:chgData name="西田　健太朗" userId="bc94bac3-4cb4-4747-a4e6-674ef9948a55" providerId="ADAL" clId="{6709D6C8-D299-463F-91F2-BE72652812B4}" dt="2026-01-08T08:40:22.129" v="0" actId="2696"/>
        <pc:sldMkLst>
          <pc:docMk/>
          <pc:sldMk cId="1081936292" sldId="301"/>
        </pc:sldMkLst>
      </pc:sldChg>
      <pc:sldChg chg="del">
        <pc:chgData name="西田　健太朗" userId="bc94bac3-4cb4-4747-a4e6-674ef9948a55" providerId="ADAL" clId="{6709D6C8-D299-463F-91F2-BE72652812B4}" dt="2026-01-08T08:40:22.129" v="0" actId="2696"/>
        <pc:sldMkLst>
          <pc:docMk/>
          <pc:sldMk cId="1594321563" sldId="302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8619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49401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366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5089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9649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0889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5725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8397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8013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91662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0269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74CEA1-474F-46A6-9D61-2F4E353C633E}" type="datetimeFigureOut">
              <a:rPr kumimoji="1" lang="ja-JP" altLang="en-US" smtClean="0"/>
              <a:t>2026/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8AFBE5-2BAA-472C-8198-20563FEFCE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4764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D47A1DCA-F558-428C-952F-9F983D9A115C}"/>
              </a:ext>
            </a:extLst>
          </p:cNvPr>
          <p:cNvSpPr txBox="1"/>
          <p:nvPr/>
        </p:nvSpPr>
        <p:spPr>
          <a:xfrm>
            <a:off x="2008822" y="5403482"/>
            <a:ext cx="8618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53853"/>
            <a:r>
              <a:rPr kumimoji="1" lang="el-GR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β</a:t>
            </a:r>
            <a:r>
              <a:rPr kumimoji="1"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415DB94-D47C-44F3-AAE1-5240A12A64BA}"/>
              </a:ext>
            </a:extLst>
          </p:cNvPr>
          <p:cNvSpPr txBox="1"/>
          <p:nvPr/>
        </p:nvSpPr>
        <p:spPr>
          <a:xfrm>
            <a:off x="203277" y="181089"/>
            <a:ext cx="428835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6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Supplemental</a:t>
            </a:r>
            <a:r>
              <a:rPr kumimoji="1" lang="ja-JP" altLang="en-US" sz="36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36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Fig.</a:t>
            </a:r>
            <a:r>
              <a:rPr kumimoji="1" lang="ja-JP" altLang="en-US" sz="36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36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5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5D37A7AF-103B-4EEA-976A-9722DFCCFA92}"/>
              </a:ext>
            </a:extLst>
          </p:cNvPr>
          <p:cNvSpPr txBox="1"/>
          <p:nvPr/>
        </p:nvSpPr>
        <p:spPr>
          <a:xfrm rot="19272057">
            <a:off x="2990199" y="3854669"/>
            <a:ext cx="11367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Untreated </a:t>
            </a: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9D024E2-739F-4033-A266-BBDDB4FE864C}"/>
              </a:ext>
            </a:extLst>
          </p:cNvPr>
          <p:cNvSpPr txBox="1"/>
          <p:nvPr/>
        </p:nvSpPr>
        <p:spPr>
          <a:xfrm flipH="1">
            <a:off x="5404664" y="4033613"/>
            <a:ext cx="5225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756D1809-F3F6-4066-8E5E-C19A3BFF3B7A}"/>
              </a:ext>
            </a:extLst>
          </p:cNvPr>
          <p:cNvSpPr txBox="1"/>
          <p:nvPr/>
        </p:nvSpPr>
        <p:spPr>
          <a:xfrm>
            <a:off x="4044091" y="4033613"/>
            <a:ext cx="4222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DB600F71-A8CE-42D4-8DF9-72CE463DFB99}"/>
              </a:ext>
            </a:extLst>
          </p:cNvPr>
          <p:cNvSpPr txBox="1"/>
          <p:nvPr/>
        </p:nvSpPr>
        <p:spPr>
          <a:xfrm>
            <a:off x="4748461" y="4033613"/>
            <a:ext cx="4386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08B5DC4A-1DE8-4B73-9D7E-B29C5B2508AE}"/>
              </a:ext>
            </a:extLst>
          </p:cNvPr>
          <p:cNvCxnSpPr>
            <a:cxnSpLocks/>
          </p:cNvCxnSpPr>
          <p:nvPr/>
        </p:nvCxnSpPr>
        <p:spPr>
          <a:xfrm>
            <a:off x="4084086" y="3994683"/>
            <a:ext cx="181217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正方形/長方形 63">
            <a:extLst>
              <a:ext uri="{FF2B5EF4-FFF2-40B4-BE49-F238E27FC236}">
                <a16:creationId xmlns:a16="http://schemas.microsoft.com/office/drawing/2014/main" id="{72D40FD9-B8BE-4409-8B9D-F151C96DA494}"/>
              </a:ext>
            </a:extLst>
          </p:cNvPr>
          <p:cNvSpPr/>
          <p:nvPr/>
        </p:nvSpPr>
        <p:spPr>
          <a:xfrm>
            <a:off x="3938441" y="3670254"/>
            <a:ext cx="210346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DXZ (mg/kg) for 48 h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DD499929-F128-FB24-BA1C-92675D2DBFB9}"/>
              </a:ext>
            </a:extLst>
          </p:cNvPr>
          <p:cNvSpPr txBox="1"/>
          <p:nvPr/>
        </p:nvSpPr>
        <p:spPr>
          <a:xfrm flipH="1">
            <a:off x="7464379" y="4033806"/>
            <a:ext cx="5225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5BAC6DFF-7362-D99F-1EBE-1D521660FF7E}"/>
              </a:ext>
            </a:extLst>
          </p:cNvPr>
          <p:cNvSpPr txBox="1"/>
          <p:nvPr/>
        </p:nvSpPr>
        <p:spPr>
          <a:xfrm>
            <a:off x="6077679" y="4033806"/>
            <a:ext cx="4222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213DAB3-E230-A145-5AD8-959E90ACB5E4}"/>
              </a:ext>
            </a:extLst>
          </p:cNvPr>
          <p:cNvSpPr txBox="1"/>
          <p:nvPr/>
        </p:nvSpPr>
        <p:spPr>
          <a:xfrm>
            <a:off x="6790758" y="4033806"/>
            <a:ext cx="4386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B49E61B7-7216-3129-F477-5F1A97FD69AE}"/>
              </a:ext>
            </a:extLst>
          </p:cNvPr>
          <p:cNvCxnSpPr>
            <a:cxnSpLocks/>
          </p:cNvCxnSpPr>
          <p:nvPr/>
        </p:nvCxnSpPr>
        <p:spPr>
          <a:xfrm>
            <a:off x="4084086" y="3994876"/>
            <a:ext cx="181217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948873A6-DDBB-B264-65CF-3C9FDBB265FF}"/>
              </a:ext>
            </a:extLst>
          </p:cNvPr>
          <p:cNvSpPr/>
          <p:nvPr/>
        </p:nvSpPr>
        <p:spPr>
          <a:xfrm>
            <a:off x="5954477" y="3670254"/>
            <a:ext cx="210346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DXZ (mg/kg) for 72 h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443BF6FA-019C-8E42-B11E-A66FE9E7FFF7}"/>
              </a:ext>
            </a:extLst>
          </p:cNvPr>
          <p:cNvCxnSpPr>
            <a:cxnSpLocks/>
          </p:cNvCxnSpPr>
          <p:nvPr/>
        </p:nvCxnSpPr>
        <p:spPr>
          <a:xfrm>
            <a:off x="6100123" y="3999226"/>
            <a:ext cx="181217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44BB8A7E-CA5A-620A-BE2B-AD9BD5A1773F}"/>
              </a:ext>
            </a:extLst>
          </p:cNvPr>
          <p:cNvCxnSpPr>
            <a:cxnSpLocks/>
          </p:cNvCxnSpPr>
          <p:nvPr/>
        </p:nvCxnSpPr>
        <p:spPr>
          <a:xfrm>
            <a:off x="3272224" y="3624603"/>
            <a:ext cx="470030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F0CBD019-00D6-7115-B89E-48419652AF68}"/>
              </a:ext>
            </a:extLst>
          </p:cNvPr>
          <p:cNvSpPr txBox="1"/>
          <p:nvPr/>
        </p:nvSpPr>
        <p:spPr>
          <a:xfrm>
            <a:off x="5364910" y="3331508"/>
            <a:ext cx="7933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lank</a:t>
            </a:r>
            <a:endParaRPr lang="ja-JP" altLang="en-US" sz="1600" dirty="0"/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293B7E56-DDC9-5ECD-BD4F-4C0927F86BD2}"/>
              </a:ext>
            </a:extLst>
          </p:cNvPr>
          <p:cNvGrpSpPr/>
          <p:nvPr/>
        </p:nvGrpSpPr>
        <p:grpSpPr>
          <a:xfrm>
            <a:off x="8210143" y="4879840"/>
            <a:ext cx="702681" cy="338554"/>
            <a:chOff x="3388623" y="4387335"/>
            <a:chExt cx="772949" cy="338554"/>
          </a:xfrm>
        </p:grpSpPr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95592DE9-1322-570D-715A-CB43CB70DB89}"/>
                </a:ext>
              </a:extLst>
            </p:cNvPr>
            <p:cNvCxnSpPr/>
            <p:nvPr/>
          </p:nvCxnSpPr>
          <p:spPr>
            <a:xfrm>
              <a:off x="3388623" y="4572001"/>
              <a:ext cx="260344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45120A6B-5A61-E008-6768-2D953E84A7F7}"/>
                </a:ext>
              </a:extLst>
            </p:cNvPr>
            <p:cNvSpPr txBox="1"/>
            <p:nvPr/>
          </p:nvSpPr>
          <p:spPr>
            <a:xfrm>
              <a:off x="3635466" y="4387335"/>
              <a:ext cx="5261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DA604563-FBFD-1166-50DA-4944860B7437}"/>
              </a:ext>
            </a:extLst>
          </p:cNvPr>
          <p:cNvGrpSpPr/>
          <p:nvPr/>
        </p:nvGrpSpPr>
        <p:grpSpPr>
          <a:xfrm>
            <a:off x="8210143" y="4299634"/>
            <a:ext cx="702681" cy="338554"/>
            <a:chOff x="3402124" y="3657992"/>
            <a:chExt cx="772949" cy="338554"/>
          </a:xfrm>
        </p:grpSpPr>
        <p:cxnSp>
          <p:nvCxnSpPr>
            <p:cNvPr id="10" name="直線コネクタ 9">
              <a:extLst>
                <a:ext uri="{FF2B5EF4-FFF2-40B4-BE49-F238E27FC236}">
                  <a16:creationId xmlns:a16="http://schemas.microsoft.com/office/drawing/2014/main" id="{22526CD6-1D03-C1B5-A626-EDB510E6184E}"/>
                </a:ext>
              </a:extLst>
            </p:cNvPr>
            <p:cNvCxnSpPr/>
            <p:nvPr/>
          </p:nvCxnSpPr>
          <p:spPr>
            <a:xfrm>
              <a:off x="3402124" y="3842658"/>
              <a:ext cx="260344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B7F502A9-4495-54C0-8C04-B4D6C12C0084}"/>
                </a:ext>
              </a:extLst>
            </p:cNvPr>
            <p:cNvSpPr txBox="1"/>
            <p:nvPr/>
          </p:nvSpPr>
          <p:spPr>
            <a:xfrm>
              <a:off x="3648967" y="3657992"/>
              <a:ext cx="52610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D3A471E1-06DC-46AA-E60D-A8B66705674B}"/>
              </a:ext>
            </a:extLst>
          </p:cNvPr>
          <p:cNvGrpSpPr/>
          <p:nvPr/>
        </p:nvGrpSpPr>
        <p:grpSpPr>
          <a:xfrm>
            <a:off x="8204969" y="5118091"/>
            <a:ext cx="599214" cy="338554"/>
            <a:chOff x="3453696" y="7544499"/>
            <a:chExt cx="659135" cy="338554"/>
          </a:xfrm>
        </p:grpSpPr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676617D6-0F0C-FD53-CCA9-C7C1FF4EE178}"/>
                </a:ext>
              </a:extLst>
            </p:cNvPr>
            <p:cNvCxnSpPr/>
            <p:nvPr/>
          </p:nvCxnSpPr>
          <p:spPr>
            <a:xfrm>
              <a:off x="3453696" y="7729165"/>
              <a:ext cx="260344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E6EC7BC1-3231-61EA-D38D-7892FE927A6A}"/>
                </a:ext>
              </a:extLst>
            </p:cNvPr>
            <p:cNvSpPr txBox="1"/>
            <p:nvPr/>
          </p:nvSpPr>
          <p:spPr>
            <a:xfrm>
              <a:off x="3700539" y="7544499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EF5AECF2-8E43-5AE5-CB15-E1EF0C3CA878}"/>
              </a:ext>
            </a:extLst>
          </p:cNvPr>
          <p:cNvGrpSpPr/>
          <p:nvPr/>
        </p:nvGrpSpPr>
        <p:grpSpPr>
          <a:xfrm>
            <a:off x="8204969" y="5691379"/>
            <a:ext cx="599214" cy="338554"/>
            <a:chOff x="3467197" y="9439312"/>
            <a:chExt cx="659135" cy="338554"/>
          </a:xfrm>
        </p:grpSpPr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7E713640-02A0-0566-34A1-5933F8CE2268}"/>
                </a:ext>
              </a:extLst>
            </p:cNvPr>
            <p:cNvCxnSpPr/>
            <p:nvPr/>
          </p:nvCxnSpPr>
          <p:spPr>
            <a:xfrm>
              <a:off x="3467197" y="9623978"/>
              <a:ext cx="260344" cy="0"/>
            </a:xfrm>
            <a:prstGeom prst="line">
              <a:avLst/>
            </a:prstGeom>
            <a:ln w="349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138D3497-ECFF-9B28-A18A-6DF85F2FA2A0}"/>
                </a:ext>
              </a:extLst>
            </p:cNvPr>
            <p:cNvSpPr txBox="1"/>
            <p:nvPr/>
          </p:nvSpPr>
          <p:spPr>
            <a:xfrm>
              <a:off x="3714040" y="9439312"/>
              <a:ext cx="4122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F9AC979-713D-6C79-2F4B-E586CD59CC28}"/>
              </a:ext>
            </a:extLst>
          </p:cNvPr>
          <p:cNvSpPr txBox="1"/>
          <p:nvPr/>
        </p:nvSpPr>
        <p:spPr>
          <a:xfrm>
            <a:off x="8339728" y="3994683"/>
            <a:ext cx="686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kDa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矢印: 右 18">
            <a:extLst>
              <a:ext uri="{FF2B5EF4-FFF2-40B4-BE49-F238E27FC236}">
                <a16:creationId xmlns:a16="http://schemas.microsoft.com/office/drawing/2014/main" id="{E7DC5FEA-4849-575B-A074-4A18FBFDAADA}"/>
              </a:ext>
            </a:extLst>
          </p:cNvPr>
          <p:cNvSpPr/>
          <p:nvPr/>
        </p:nvSpPr>
        <p:spPr>
          <a:xfrm>
            <a:off x="2809467" y="4649575"/>
            <a:ext cx="225276" cy="146957"/>
          </a:xfrm>
          <a:prstGeom prst="rightArrow">
            <a:avLst>
              <a:gd name="adj1" fmla="val 39629"/>
              <a:gd name="adj2" fmla="val 5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矢印: 右 19">
            <a:extLst>
              <a:ext uri="{FF2B5EF4-FFF2-40B4-BE49-F238E27FC236}">
                <a16:creationId xmlns:a16="http://schemas.microsoft.com/office/drawing/2014/main" id="{B74D733F-56F7-E237-6197-6C7AE0A49A13}"/>
              </a:ext>
            </a:extLst>
          </p:cNvPr>
          <p:cNvSpPr/>
          <p:nvPr/>
        </p:nvSpPr>
        <p:spPr>
          <a:xfrm>
            <a:off x="2817327" y="5527522"/>
            <a:ext cx="225276" cy="146957"/>
          </a:xfrm>
          <a:prstGeom prst="rightArrow">
            <a:avLst>
              <a:gd name="adj1" fmla="val 39629"/>
              <a:gd name="adj2" fmla="val 50000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34" name="図 33" descr="コンピューターのスクリーンショット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1FC9506D-6684-B37F-5EB5-2E8C2F98254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39" t="17482" r="15804" b="69516"/>
          <a:stretch/>
        </p:blipFill>
        <p:spPr>
          <a:xfrm>
            <a:off x="3085374" y="4415439"/>
            <a:ext cx="5064120" cy="69634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6" name="図 35" descr="コンピューターのスクリーンショット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7CB13AA8-3AC6-3AFC-CF76-740485BC8F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42" t="39583" r="15701" b="45998"/>
          <a:stretch/>
        </p:blipFill>
        <p:spPr>
          <a:xfrm>
            <a:off x="3085374" y="5232060"/>
            <a:ext cx="5064120" cy="77221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88B752E5-2374-9CB1-7B40-80E59F77C9C0}"/>
              </a:ext>
            </a:extLst>
          </p:cNvPr>
          <p:cNvPicPr>
            <a:picLocks/>
          </p:cNvPicPr>
          <p:nvPr/>
        </p:nvPicPr>
        <p:blipFill>
          <a:blip r:embed="rId3"/>
          <a:srcRect l="4952" b="16674"/>
          <a:stretch/>
        </p:blipFill>
        <p:spPr>
          <a:xfrm>
            <a:off x="3054984" y="6046673"/>
            <a:ext cx="5064120" cy="22860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C8BBC0B-CAFA-444C-4080-202E1F604A05}"/>
              </a:ext>
            </a:extLst>
          </p:cNvPr>
          <p:cNvSpPr txBox="1"/>
          <p:nvPr/>
        </p:nvSpPr>
        <p:spPr>
          <a:xfrm>
            <a:off x="1713588" y="3359915"/>
            <a:ext cx="35137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590840">
              <a:defRPr/>
            </a:pPr>
            <a:r>
              <a:rPr kumimoji="1" lang="en-US" altLang="ja-JP" sz="2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en-US" altLang="ja-JP" sz="2400" dirty="0">
              <a:solidFill>
                <a:prstClr val="black"/>
              </a:solidFill>
              <a:latin typeface="ＭＳ Ｐゴシック" panose="020B0600070205080204" pitchFamily="50" charset="-128"/>
              <a:ea typeface="ＭＳ Ｐゴシック" panose="020B0600070205080204" pitchFamily="50" charset="-128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E52A992-55A1-6B0C-346D-A49ED43BBD66}"/>
              </a:ext>
            </a:extLst>
          </p:cNvPr>
          <p:cNvSpPr txBox="1"/>
          <p:nvPr/>
        </p:nvSpPr>
        <p:spPr>
          <a:xfrm rot="16200000">
            <a:off x="1283998" y="6969832"/>
            <a:ext cx="2296784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opo II</a:t>
            </a:r>
            <a:r>
              <a:rPr kumimoji="1" lang="el-GR" altLang="ja-JP" sz="1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β</a:t>
            </a:r>
            <a:r>
              <a:rPr kumimoji="1"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expression levels </a:t>
            </a:r>
          </a:p>
          <a:p>
            <a:pPr algn="ctr"/>
            <a:r>
              <a:rPr kumimoji="1"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</a:t>
            </a:r>
            <a:r>
              <a:rPr kumimoji="1" lang="en-US" altLang="ja-JP" sz="1400" dirty="0" err="1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.u</a:t>
            </a:r>
            <a:r>
              <a:rPr kumimoji="1"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.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EE1221E5-69E5-A962-7F52-2126564B3877}"/>
              </a:ext>
            </a:extLst>
          </p:cNvPr>
          <p:cNvSpPr/>
          <p:nvPr/>
        </p:nvSpPr>
        <p:spPr>
          <a:xfrm>
            <a:off x="1713588" y="6015500"/>
            <a:ext cx="38985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ja-JP" sz="24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B</a:t>
            </a:r>
            <a:endParaRPr lang="ja-JP" altLang="en-US" sz="24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CC82143-C5AD-0DD8-506A-FF3706505479}"/>
              </a:ext>
            </a:extLst>
          </p:cNvPr>
          <p:cNvSpPr txBox="1"/>
          <p:nvPr/>
        </p:nvSpPr>
        <p:spPr>
          <a:xfrm>
            <a:off x="1847649" y="4550328"/>
            <a:ext cx="9996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53853"/>
            <a:r>
              <a:rPr kumimoji="1" lang="en-US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Topo II</a:t>
            </a:r>
            <a:r>
              <a:rPr kumimoji="1" lang="el-GR" altLang="ja-JP" sz="16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β</a:t>
            </a:r>
            <a:endParaRPr kumimoji="1" lang="ja-JP" altLang="en-US" sz="1600" dirty="0">
              <a:solidFill>
                <a:prstClr val="black"/>
              </a:solidFill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A063EF7-667A-3977-7679-E9796C8693AB}"/>
              </a:ext>
            </a:extLst>
          </p:cNvPr>
          <p:cNvSpPr txBox="1"/>
          <p:nvPr/>
        </p:nvSpPr>
        <p:spPr>
          <a:xfrm rot="19272057">
            <a:off x="2742337" y="8498835"/>
            <a:ext cx="11367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Untreated 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683BFEC-671D-10F0-BC17-44FBC1AAE928}"/>
              </a:ext>
            </a:extLst>
          </p:cNvPr>
          <p:cNvSpPr txBox="1"/>
          <p:nvPr/>
        </p:nvSpPr>
        <p:spPr>
          <a:xfrm flipH="1">
            <a:off x="5287107" y="8329558"/>
            <a:ext cx="5225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9AF27A3-FFC2-0746-C473-2EBBA2A2E99C}"/>
              </a:ext>
            </a:extLst>
          </p:cNvPr>
          <p:cNvSpPr txBox="1"/>
          <p:nvPr/>
        </p:nvSpPr>
        <p:spPr>
          <a:xfrm>
            <a:off x="3926534" y="8329558"/>
            <a:ext cx="4222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826871E8-1898-20FC-2458-977598B84EA3}"/>
              </a:ext>
            </a:extLst>
          </p:cNvPr>
          <p:cNvSpPr txBox="1"/>
          <p:nvPr/>
        </p:nvSpPr>
        <p:spPr>
          <a:xfrm>
            <a:off x="4630904" y="8329558"/>
            <a:ext cx="4386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518D5168-8A00-9F29-4AD4-4C764CDCC0E8}"/>
              </a:ext>
            </a:extLst>
          </p:cNvPr>
          <p:cNvSpPr/>
          <p:nvPr/>
        </p:nvSpPr>
        <p:spPr>
          <a:xfrm>
            <a:off x="3902244" y="8671158"/>
            <a:ext cx="185499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XZ (mg/kg) for 48 h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BC976FE3-A4CE-C5CC-E149-0ADB0D96A37E}"/>
              </a:ext>
            </a:extLst>
          </p:cNvPr>
          <p:cNvSpPr txBox="1"/>
          <p:nvPr/>
        </p:nvSpPr>
        <p:spPr>
          <a:xfrm flipH="1">
            <a:off x="7397622" y="8329751"/>
            <a:ext cx="5225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3A55B692-8F60-D43D-C37A-F2EC6B799718}"/>
              </a:ext>
            </a:extLst>
          </p:cNvPr>
          <p:cNvSpPr txBox="1"/>
          <p:nvPr/>
        </p:nvSpPr>
        <p:spPr>
          <a:xfrm>
            <a:off x="6042672" y="8329751"/>
            <a:ext cx="4222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CA6094A6-A50D-514F-99E2-AFA7CC97B5F1}"/>
              </a:ext>
            </a:extLst>
          </p:cNvPr>
          <p:cNvSpPr txBox="1"/>
          <p:nvPr/>
        </p:nvSpPr>
        <p:spPr>
          <a:xfrm>
            <a:off x="6730351" y="8329751"/>
            <a:ext cx="4386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7AFCBEC1-59B8-136D-DFB9-ED0445B31897}"/>
              </a:ext>
            </a:extLst>
          </p:cNvPr>
          <p:cNvCxnSpPr>
            <a:cxnSpLocks/>
          </p:cNvCxnSpPr>
          <p:nvPr/>
        </p:nvCxnSpPr>
        <p:spPr>
          <a:xfrm>
            <a:off x="3915767" y="8656498"/>
            <a:ext cx="18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E59F01B4-2BFC-E578-FDA3-DCC7B408230B}"/>
              </a:ext>
            </a:extLst>
          </p:cNvPr>
          <p:cNvSpPr/>
          <p:nvPr/>
        </p:nvSpPr>
        <p:spPr>
          <a:xfrm>
            <a:off x="6045280" y="8671158"/>
            <a:ext cx="185499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DXZ (mg/kg) for 72 h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95224EEB-347F-5164-C549-194538782CB5}"/>
              </a:ext>
            </a:extLst>
          </p:cNvPr>
          <p:cNvCxnSpPr>
            <a:cxnSpLocks/>
          </p:cNvCxnSpPr>
          <p:nvPr/>
        </p:nvCxnSpPr>
        <p:spPr>
          <a:xfrm>
            <a:off x="6020704" y="8656498"/>
            <a:ext cx="187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77B5479E-C1C4-6CD3-774D-E859C5E1DCD4}"/>
              </a:ext>
            </a:extLst>
          </p:cNvPr>
          <p:cNvSpPr txBox="1"/>
          <p:nvPr/>
        </p:nvSpPr>
        <p:spPr>
          <a:xfrm>
            <a:off x="2770903" y="8121855"/>
            <a:ext cx="4222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317D2FA2-EC18-A8AB-F8CA-E6E6844FFA40}"/>
              </a:ext>
            </a:extLst>
          </p:cNvPr>
          <p:cNvSpPr txBox="1"/>
          <p:nvPr/>
        </p:nvSpPr>
        <p:spPr>
          <a:xfrm>
            <a:off x="2688290" y="7814549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CBCAC94A-D5F9-FF04-A750-D91B08C5B481}"/>
              </a:ext>
            </a:extLst>
          </p:cNvPr>
          <p:cNvSpPr txBox="1"/>
          <p:nvPr/>
        </p:nvSpPr>
        <p:spPr>
          <a:xfrm>
            <a:off x="2688290" y="7520448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642C0528-239B-8E7D-0757-CA9EFB68EB50}"/>
              </a:ext>
            </a:extLst>
          </p:cNvPr>
          <p:cNvSpPr txBox="1"/>
          <p:nvPr/>
        </p:nvSpPr>
        <p:spPr>
          <a:xfrm>
            <a:off x="2688290" y="7229016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372C4070-89D8-0652-B9F7-3B0D07AA94F8}"/>
              </a:ext>
            </a:extLst>
          </p:cNvPr>
          <p:cNvSpPr txBox="1"/>
          <p:nvPr/>
        </p:nvSpPr>
        <p:spPr>
          <a:xfrm>
            <a:off x="2688290" y="6932769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AAF781D4-8EFC-3643-E797-E97E0D13D359}"/>
              </a:ext>
            </a:extLst>
          </p:cNvPr>
          <p:cNvSpPr txBox="1"/>
          <p:nvPr/>
        </p:nvSpPr>
        <p:spPr>
          <a:xfrm>
            <a:off x="2688290" y="6638825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374877A1-42F5-708E-3FEB-6DF63DC17174}"/>
              </a:ext>
            </a:extLst>
          </p:cNvPr>
          <p:cNvSpPr txBox="1"/>
          <p:nvPr/>
        </p:nvSpPr>
        <p:spPr>
          <a:xfrm>
            <a:off x="2688290" y="6344136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.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20D67C58-379F-0787-FEF9-258A1B174EFA}"/>
              </a:ext>
            </a:extLst>
          </p:cNvPr>
          <p:cNvSpPr txBox="1"/>
          <p:nvPr/>
        </p:nvSpPr>
        <p:spPr>
          <a:xfrm>
            <a:off x="2688290" y="6041144"/>
            <a:ext cx="504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.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731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EC33B5BD4E644C4D8D57583994C724B6" ma:contentTypeVersion="15" ma:contentTypeDescription="新しいドキュメントを作成します。" ma:contentTypeScope="" ma:versionID="581ef8f523f6df2d3dcbd90b34743d18">
  <xsd:schema xmlns:xsd="http://www.w3.org/2001/XMLSchema" xmlns:xs="http://www.w3.org/2001/XMLSchema" xmlns:p="http://schemas.microsoft.com/office/2006/metadata/properties" xmlns:ns3="d46048f6-b81f-43a4-8afc-a6570ccfb14b" xmlns:ns4="51e9e23c-c15a-4fef-a277-c63d94d447eb" targetNamespace="http://schemas.microsoft.com/office/2006/metadata/properties" ma:root="true" ma:fieldsID="c1daa78ff8b52bbdaa7f01933a7c6b7a" ns3:_="" ns4:_="">
    <xsd:import namespace="d46048f6-b81f-43a4-8afc-a6570ccfb14b"/>
    <xsd:import namespace="51e9e23c-c15a-4fef-a277-c63d94d447e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46048f6-b81f-43a4-8afc-a6570ccfb14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internalName="MediaServiceAutoTags" ma:readOnly="true">
      <xsd:simpleType>
        <xsd:restriction base="dms:Text"/>
      </xsd:simpleType>
    </xsd:element>
    <xsd:element name="MediaServiceOCR" ma:index="12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1e9e23c-c15a-4fef-a277-c63d94d447eb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共有のヒントのハッシュ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d46048f6-b81f-43a4-8afc-a6570ccfb14b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211CE79A-5FB6-4A5F-AED1-DD9FF18F6BD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46048f6-b81f-43a4-8afc-a6570ccfb14b"/>
    <ds:schemaRef ds:uri="51e9e23c-c15a-4fef-a277-c63d94d447e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4E759A7-835B-42E2-BA5B-EB89C93D1B70}">
  <ds:schemaRefs>
    <ds:schemaRef ds:uri="http://www.w3.org/XML/1998/namespace"/>
    <ds:schemaRef ds:uri="http://purl.org/dc/elements/1.1/"/>
    <ds:schemaRef ds:uri="http://schemas.microsoft.com/office/2006/metadata/properties"/>
    <ds:schemaRef ds:uri="http://schemas.microsoft.com/office/infopath/2007/PartnerControls"/>
    <ds:schemaRef ds:uri="d46048f6-b81f-43a4-8afc-a6570ccfb14b"/>
    <ds:schemaRef ds:uri="51e9e23c-c15a-4fef-a277-c63d94d447eb"/>
    <ds:schemaRef ds:uri="http://schemas.openxmlformats.org/package/2006/metadata/core-properties"/>
    <ds:schemaRef ds:uri="http://schemas.microsoft.com/office/2006/documentManagement/types"/>
    <ds:schemaRef ds:uri="http://purl.org/dc/dcmitype/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ABD4149F-7E02-4E7F-94BF-1A6DE4B3BD63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37</TotalTime>
  <Words>87</Words>
  <Application>Microsoft Office PowerPoint</Application>
  <PresentationFormat>A3 297x420 mm</PresentationFormat>
  <Paragraphs>3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薬学国試</dc:creator>
  <cp:lastModifiedBy>西田　健太朗</cp:lastModifiedBy>
  <cp:revision>86</cp:revision>
  <cp:lastPrinted>2024-02-26T10:17:30Z</cp:lastPrinted>
  <dcterms:created xsi:type="dcterms:W3CDTF">2022-11-15T04:47:13Z</dcterms:created>
  <dcterms:modified xsi:type="dcterms:W3CDTF">2026-01-09T05:36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C33B5BD4E644C4D8D57583994C724B6</vt:lpwstr>
  </property>
</Properties>
</file>